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handoutMasterIdLst>
    <p:handoutMasterId r:id="rId8"/>
  </p:handoutMasterIdLst>
  <p:sldIdLst>
    <p:sldId id="433" r:id="rId2"/>
    <p:sldId id="436" r:id="rId3"/>
    <p:sldId id="437" r:id="rId4"/>
    <p:sldId id="435" r:id="rId5"/>
    <p:sldId id="434" r:id="rId6"/>
  </p:sldIdLst>
  <p:sldSz cx="6858000" cy="9144000" type="screen4x3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Hanate" initials="Hanate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D5FF"/>
    <a:srgbClr val="99FF66"/>
    <a:srgbClr val="CCFF66"/>
    <a:srgbClr val="CCFF99"/>
    <a:srgbClr val="FFFFCC"/>
    <a:srgbClr val="FFE5FF"/>
    <a:srgbClr val="FFCCFF"/>
    <a:srgbClr val="F7257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589" autoAdjust="0"/>
    <p:restoredTop sz="96429" autoAdjust="0"/>
  </p:normalViewPr>
  <p:slideViewPr>
    <p:cSldViewPr>
      <p:cViewPr varScale="1">
        <p:scale>
          <a:sx n="87" d="100"/>
          <a:sy n="87" d="100"/>
        </p:scale>
        <p:origin x="2814" y="12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-199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ACFF01-93A8-41C8-B4EA-8F43424FB431}" type="datetimeFigureOut">
              <a:rPr kumimoji="1" lang="ja-JP" altLang="en-US" smtClean="0"/>
              <a:t>2019/6/2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D776C6-638D-48B3-B4B4-E8780FA3CA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596121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152136B-DFB0-43CC-9E35-6E46679A27CA}" type="datetimeFigureOut">
              <a:rPr kumimoji="1" lang="ja-JP" altLang="en-US" smtClean="0"/>
              <a:pPr/>
              <a:t>2019/6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54268E-FE81-4513-B066-5A2B212A5C8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7332716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E2A2898-4B78-1F40-BDD3-03EBCFD8481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908812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E2A2898-4B78-1F40-BDD3-03EBCFD84816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75300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E2A2898-4B78-1F40-BDD3-03EBCFD84816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174337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E2A2898-4B78-1F40-BDD3-03EBCFD84816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140519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E2A2898-4B78-1F40-BDD3-03EBCFD84816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38282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92E45-21F3-47BC-98CD-5431352C9DCC}" type="datetime1">
              <a:rPr kumimoji="1" lang="ja-JP" altLang="en-US" smtClean="0"/>
              <a:t>2019/6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14193-75D2-4092-9BDC-F095491EC3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50727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802D1-F188-4671-81CC-AF4B814430E5}" type="datetime1">
              <a:rPr kumimoji="1" lang="ja-JP" altLang="en-US" smtClean="0"/>
              <a:t>2019/6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14193-75D2-4092-9BDC-F095491EC3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20986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07756" y="486834"/>
            <a:ext cx="1478756" cy="774911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71487" y="486834"/>
            <a:ext cx="4350544" cy="774911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51AE53-DD8F-4454-B173-36197C206030}" type="datetime1">
              <a:rPr kumimoji="1" lang="ja-JP" altLang="en-US" smtClean="0"/>
              <a:t>2019/6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14193-75D2-4092-9BDC-F095491EC3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27246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79474-C54A-4FB0-A355-6841B132DD7B}" type="datetime1">
              <a:rPr kumimoji="1" lang="ja-JP" altLang="en-US" smtClean="0"/>
              <a:t>2019/6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14193-75D2-4092-9BDC-F095491EC3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3229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CF598-61E3-40E4-A586-7E5940C32CFB}" type="datetime1">
              <a:rPr kumimoji="1" lang="ja-JP" altLang="en-US" smtClean="0"/>
              <a:t>2019/6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14193-75D2-4092-9BDC-F095491EC3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4437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A9872-5971-498F-9CB1-25DA55276E4A}" type="datetime1">
              <a:rPr kumimoji="1" lang="ja-JP" altLang="en-US" smtClean="0"/>
              <a:t>2019/6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14193-75D2-4092-9BDC-F095491EC3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69942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072BC-54CE-4E3E-A2DC-E9215AEABB70}" type="datetime1">
              <a:rPr kumimoji="1" lang="ja-JP" altLang="en-US" smtClean="0"/>
              <a:t>2019/6/2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14193-75D2-4092-9BDC-F095491EC3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19449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8D88E-E8E5-4B32-8BBB-599CCB8F6E25}" type="datetime1">
              <a:rPr kumimoji="1" lang="ja-JP" altLang="en-US" smtClean="0"/>
              <a:t>2019/6/2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14193-75D2-4092-9BDC-F095491EC3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22216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53E20-97F3-4E70-9ABC-75715F260836}" type="datetime1">
              <a:rPr kumimoji="1" lang="ja-JP" altLang="en-US" smtClean="0"/>
              <a:t>2019/6/2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14193-75D2-4092-9BDC-F095491EC3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34071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709A1-3D6D-4BFF-B2D6-35713C3ABEA9}" type="datetime1">
              <a:rPr kumimoji="1" lang="ja-JP" altLang="en-US" smtClean="0"/>
              <a:t>2019/6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14193-75D2-4092-9BDC-F095491EC3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34086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8E3DCF-54F5-4C15-8096-E834081CF585}" type="datetime1">
              <a:rPr kumimoji="1" lang="ja-JP" altLang="en-US" smtClean="0"/>
              <a:t>2019/6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14193-75D2-4092-9BDC-F095491EC3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18646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B0C39B-EBF2-4F64-A2D9-CA2AAEAAB001}" type="datetime1">
              <a:rPr kumimoji="1" lang="ja-JP" altLang="en-US" smtClean="0"/>
              <a:t>2019/6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814193-75D2-4092-9BDC-F095491EC3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863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 dt="0"/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kumimoji="1"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kumimoji="1"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9" name="テキスト ボックス 208"/>
          <p:cNvSpPr txBox="1"/>
          <p:nvPr/>
        </p:nvSpPr>
        <p:spPr>
          <a:xfrm>
            <a:off x="129332" y="299908"/>
            <a:ext cx="65482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ea typeface="Osaka" charset="-128"/>
                <a:cs typeface="Times New Roman" panose="02020603050405020304" pitchFamily="18" charset="0"/>
              </a:rPr>
              <a:t>Table </a:t>
            </a:r>
            <a:r>
              <a:rPr lang="en-US" altLang="ja-JP" sz="1200" dirty="0">
                <a:latin typeface="Times New Roman" panose="02020603050405020304" pitchFamily="18" charset="0"/>
                <a:ea typeface="Osaka" charset="-128"/>
                <a:cs typeface="Times New Roman" panose="02020603050405020304" pitchFamily="18" charset="0"/>
              </a:rPr>
              <a:t>S1. Results of genome-wide association analysis that compares heavy coffee consumers with others</a:t>
            </a:r>
            <a:endParaRPr lang="ja-JP" altLang="en-US" sz="1200" dirty="0">
              <a:latin typeface="Times New Roman" panose="02020603050405020304" pitchFamily="18" charset="0"/>
              <a:ea typeface="Osaka" charset="-128"/>
              <a:cs typeface="Times New Roman" panose="02020603050405020304" pitchFamily="18" charset="0"/>
            </a:endParaRPr>
          </a:p>
          <a:p>
            <a:r>
              <a:rPr lang="en-US" altLang="ja-JP" sz="1200" dirty="0" smtClean="0">
                <a:latin typeface="Times New Roman" panose="02020603050405020304" pitchFamily="18" charset="0"/>
                <a:ea typeface="Osaka" charset="-128"/>
                <a:cs typeface="Times New Roman" panose="02020603050405020304" pitchFamily="18" charset="0"/>
              </a:rPr>
              <a:t> </a:t>
            </a:r>
            <a:endParaRPr lang="ja-JP" altLang="en-US" sz="1200" dirty="0">
              <a:latin typeface="Times New Roman" panose="02020603050405020304" pitchFamily="18" charset="0"/>
              <a:ea typeface="Osaka" charset="-128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E1129EA-9B1E-AA45-BF74-3E52BA3C76E7}"/>
              </a:ext>
            </a:extLst>
          </p:cNvPr>
          <p:cNvSpPr txBox="1"/>
          <p:nvPr/>
        </p:nvSpPr>
        <p:spPr>
          <a:xfrm>
            <a:off x="129333" y="3469900"/>
            <a:ext cx="6612036" cy="475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46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, chromosome; EA, effect allele; NEA, non-effect allele; EAF, effect allele frequency; OR, odds ratio; CI, confidence interval</a:t>
            </a:r>
            <a:endParaRPr lang="ja-JP" altLang="en-US" sz="124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1A5D9F5F-14BF-EC40-B458-B2061DFB512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49395754"/>
              </p:ext>
            </p:extLst>
          </p:nvPr>
        </p:nvGraphicFramePr>
        <p:xfrm>
          <a:off x="203964" y="777452"/>
          <a:ext cx="6537404" cy="2653232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654038">
                  <a:extLst>
                    <a:ext uri="{9D8B030D-6E8A-4147-A177-3AD203B41FA5}">
                      <a16:colId xmlns:a16="http://schemas.microsoft.com/office/drawing/2014/main" val="242114697"/>
                    </a:ext>
                  </a:extLst>
                </a:gridCol>
                <a:gridCol w="315251">
                  <a:extLst>
                    <a:ext uri="{9D8B030D-6E8A-4147-A177-3AD203B41FA5}">
                      <a16:colId xmlns:a16="http://schemas.microsoft.com/office/drawing/2014/main" val="1724535601"/>
                    </a:ext>
                  </a:extLst>
                </a:gridCol>
                <a:gridCol w="794188">
                  <a:extLst>
                    <a:ext uri="{9D8B030D-6E8A-4147-A177-3AD203B41FA5}">
                      <a16:colId xmlns:a16="http://schemas.microsoft.com/office/drawing/2014/main" val="3294465575"/>
                    </a:ext>
                  </a:extLst>
                </a:gridCol>
                <a:gridCol w="233133">
                  <a:extLst>
                    <a:ext uri="{9D8B030D-6E8A-4147-A177-3AD203B41FA5}">
                      <a16:colId xmlns:a16="http://schemas.microsoft.com/office/drawing/2014/main" val="2530908919"/>
                    </a:ext>
                  </a:extLst>
                </a:gridCol>
                <a:gridCol w="333802">
                  <a:extLst>
                    <a:ext uri="{9D8B030D-6E8A-4147-A177-3AD203B41FA5}">
                      <a16:colId xmlns:a16="http://schemas.microsoft.com/office/drawing/2014/main" val="4255172620"/>
                    </a:ext>
                  </a:extLst>
                </a:gridCol>
                <a:gridCol w="786523">
                  <a:extLst>
                    <a:ext uri="{9D8B030D-6E8A-4147-A177-3AD203B41FA5}">
                      <a16:colId xmlns:a16="http://schemas.microsoft.com/office/drawing/2014/main" val="2440816001"/>
                    </a:ext>
                  </a:extLst>
                </a:gridCol>
                <a:gridCol w="504543">
                  <a:extLst>
                    <a:ext uri="{9D8B030D-6E8A-4147-A177-3AD203B41FA5}">
                      <a16:colId xmlns:a16="http://schemas.microsoft.com/office/drawing/2014/main" val="2978196288"/>
                    </a:ext>
                  </a:extLst>
                </a:gridCol>
                <a:gridCol w="962369">
                  <a:extLst>
                    <a:ext uri="{9D8B030D-6E8A-4147-A177-3AD203B41FA5}">
                      <a16:colId xmlns:a16="http://schemas.microsoft.com/office/drawing/2014/main" val="3235405731"/>
                    </a:ext>
                  </a:extLst>
                </a:gridCol>
                <a:gridCol w="671176">
                  <a:extLst>
                    <a:ext uri="{9D8B030D-6E8A-4147-A177-3AD203B41FA5}">
                      <a16:colId xmlns:a16="http://schemas.microsoft.com/office/drawing/2014/main" val="2286299703"/>
                    </a:ext>
                  </a:extLst>
                </a:gridCol>
                <a:gridCol w="504543">
                  <a:extLst>
                    <a:ext uri="{9D8B030D-6E8A-4147-A177-3AD203B41FA5}">
                      <a16:colId xmlns:a16="http://schemas.microsoft.com/office/drawing/2014/main" val="1212334588"/>
                    </a:ext>
                  </a:extLst>
                </a:gridCol>
                <a:gridCol w="777838">
                  <a:extLst>
                    <a:ext uri="{9D8B030D-6E8A-4147-A177-3AD203B41FA5}">
                      <a16:colId xmlns:a16="http://schemas.microsoft.com/office/drawing/2014/main" val="2538775386"/>
                    </a:ext>
                  </a:extLst>
                </a:gridCol>
              </a:tblGrid>
              <a:tr h="154844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riant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r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ition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A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A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pulation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AF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 (95% CI)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lang="en" sz="105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" sz="105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" sz="1050" u="none" strike="noStrike" baseline="-25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terogeneity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814322"/>
                  </a:ext>
                </a:extLst>
              </a:tr>
              <a:tr h="154844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s75060857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6,234,510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2 (1.22–1.67)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8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146199042"/>
                  </a:ext>
                </a:extLst>
              </a:tr>
              <a:tr h="154844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plication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2 (0.77–1.10)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extLst>
                  <a:ext uri="{0D108BD9-81ED-4DB2-BD59-A6C34878D82A}">
                    <a16:rowId xmlns:a16="http://schemas.microsoft.com/office/drawing/2014/main" val="482763479"/>
                  </a:ext>
                </a:extLst>
              </a:tr>
              <a:tr h="154844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a-analysis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7 (1.04–1.32)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9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.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653981"/>
                  </a:ext>
                </a:extLst>
              </a:tr>
              <a:tr h="154844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s11722777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,590,819 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1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 (0.67–0.85)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642853481"/>
                  </a:ext>
                </a:extLst>
              </a:tr>
              <a:tr h="154844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plication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 (0.79–1.01)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extLst>
                  <a:ext uri="{0D108BD9-81ED-4DB2-BD59-A6C34878D82A}">
                    <a16:rowId xmlns:a16="http://schemas.microsoft.com/office/drawing/2014/main" val="3022899542"/>
                  </a:ext>
                </a:extLst>
              </a:tr>
              <a:tr h="154844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a-analysis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1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 (0.75–0.89)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4.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3628715"/>
                  </a:ext>
                </a:extLst>
              </a:tr>
              <a:tr h="154844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s4410790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,284,577 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6 (1.15–1.37)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8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725945179"/>
                  </a:ext>
                </a:extLst>
              </a:tr>
              <a:tr h="154844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plication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1 (1.20–1.44)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extLst>
                  <a:ext uri="{0D108BD9-81ED-4DB2-BD59-A6C34878D82A}">
                    <a16:rowId xmlns:a16="http://schemas.microsoft.com/office/drawing/2014/main" val="1161648537"/>
                  </a:ext>
                </a:extLst>
              </a:tr>
              <a:tr h="154844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a-analysis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8 (1.21–1.37)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0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1027447"/>
                  </a:ext>
                </a:extLst>
              </a:tr>
              <a:tr h="154844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s11066001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2,119,171 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9 (1.17–1.43)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842395268"/>
                  </a:ext>
                </a:extLst>
              </a:tr>
              <a:tr h="154844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plication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9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6 (1.15–1.39)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extLst>
                  <a:ext uri="{0D108BD9-81ED-4DB2-BD59-A6C34878D82A}">
                    <a16:rowId xmlns:a16="http://schemas.microsoft.com/office/drawing/2014/main" val="3301535243"/>
                  </a:ext>
                </a:extLst>
              </a:tr>
              <a:tr h="154844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a-analysis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8 (1.19–1.37)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5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24058"/>
                  </a:ext>
                </a:extLst>
              </a:tr>
              <a:tr h="154844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s16951547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,585,898 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0 (0.72–0.88)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951538735"/>
                  </a:ext>
                </a:extLst>
              </a:tr>
              <a:tr h="154844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plication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2 (0.92–1.13)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/>
                </a:tc>
                <a:extLst>
                  <a:ext uri="{0D108BD9-81ED-4DB2-BD59-A6C34878D82A}">
                    <a16:rowId xmlns:a16="http://schemas.microsoft.com/office/drawing/2014/main" val="4128581914"/>
                  </a:ext>
                </a:extLst>
              </a:tr>
              <a:tr h="154844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a-analysis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 (0.84–0.97)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.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1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5807" marR="5807" marT="58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490605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244384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9" name="テキスト ボックス 208"/>
          <p:cNvSpPr txBox="1"/>
          <p:nvPr/>
        </p:nvSpPr>
        <p:spPr>
          <a:xfrm>
            <a:off x="129332" y="299908"/>
            <a:ext cx="65482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ea typeface="Osaka" charset="-128"/>
                <a:cs typeface="Times New Roman" panose="02020603050405020304" pitchFamily="18" charset="0"/>
              </a:rPr>
              <a:t>Table </a:t>
            </a:r>
            <a:r>
              <a:rPr lang="en-US" altLang="ja-JP" sz="1200" dirty="0">
                <a:latin typeface="Times New Roman" panose="02020603050405020304" pitchFamily="18" charset="0"/>
                <a:ea typeface="Osaka" charset="-128"/>
                <a:cs typeface="Times New Roman" panose="02020603050405020304" pitchFamily="18" charset="0"/>
              </a:rPr>
              <a:t>S2. Results of genome-wide association analysis based on </a:t>
            </a:r>
            <a:r>
              <a:rPr lang="en-US" altLang="ja-JP" sz="1200" dirty="0" smtClean="0">
                <a:latin typeface="Times New Roman" panose="02020603050405020304" pitchFamily="18" charset="0"/>
                <a:ea typeface="Osaka" charset="-128"/>
                <a:cs typeface="Times New Roman" panose="02020603050405020304" pitchFamily="18" charset="0"/>
              </a:rPr>
              <a:t>a dominant </a:t>
            </a:r>
            <a:r>
              <a:rPr lang="en-US" altLang="ja-JP" sz="1200" dirty="0">
                <a:latin typeface="Times New Roman" panose="02020603050405020304" pitchFamily="18" charset="0"/>
                <a:ea typeface="Osaka" charset="-128"/>
                <a:cs typeface="Times New Roman" panose="02020603050405020304" pitchFamily="18" charset="0"/>
              </a:rPr>
              <a:t>model</a:t>
            </a:r>
            <a:endParaRPr lang="ja-JP" altLang="en-US" sz="1200" dirty="0">
              <a:latin typeface="Times New Roman" panose="02020603050405020304" pitchFamily="18" charset="0"/>
              <a:ea typeface="Osaka" charset="-128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E1129EA-9B1E-AA45-BF74-3E52BA3C76E7}"/>
              </a:ext>
            </a:extLst>
          </p:cNvPr>
          <p:cNvSpPr txBox="1"/>
          <p:nvPr/>
        </p:nvSpPr>
        <p:spPr>
          <a:xfrm>
            <a:off x="129333" y="3304141"/>
            <a:ext cx="6612036" cy="475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46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, chromosome; EA, effect allele; NEA, non-effect allele; EAF, effect allele frequency; SE, standard error</a:t>
            </a:r>
            <a:endParaRPr lang="ja-JP" altLang="en-US" sz="124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5CB2E09D-0542-CA4D-858C-E1F79888BB7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08519603"/>
              </p:ext>
            </p:extLst>
          </p:nvPr>
        </p:nvGraphicFramePr>
        <p:xfrm>
          <a:off x="129332" y="683568"/>
          <a:ext cx="6548286" cy="2510384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773080">
                  <a:extLst>
                    <a:ext uri="{9D8B030D-6E8A-4147-A177-3AD203B41FA5}">
                      <a16:colId xmlns:a16="http://schemas.microsoft.com/office/drawing/2014/main" val="2017757483"/>
                    </a:ext>
                  </a:extLst>
                </a:gridCol>
                <a:gridCol w="282241">
                  <a:extLst>
                    <a:ext uri="{9D8B030D-6E8A-4147-A177-3AD203B41FA5}">
                      <a16:colId xmlns:a16="http://schemas.microsoft.com/office/drawing/2014/main" val="2006002712"/>
                    </a:ext>
                  </a:extLst>
                </a:gridCol>
                <a:gridCol w="883804">
                  <a:extLst>
                    <a:ext uri="{9D8B030D-6E8A-4147-A177-3AD203B41FA5}">
                      <a16:colId xmlns:a16="http://schemas.microsoft.com/office/drawing/2014/main" val="1535828393"/>
                    </a:ext>
                  </a:extLst>
                </a:gridCol>
                <a:gridCol w="256882">
                  <a:extLst>
                    <a:ext uri="{9D8B030D-6E8A-4147-A177-3AD203B41FA5}">
                      <a16:colId xmlns:a16="http://schemas.microsoft.com/office/drawing/2014/main" val="2081131377"/>
                    </a:ext>
                  </a:extLst>
                </a:gridCol>
                <a:gridCol w="367367">
                  <a:extLst>
                    <a:ext uri="{9D8B030D-6E8A-4147-A177-3AD203B41FA5}">
                      <a16:colId xmlns:a16="http://schemas.microsoft.com/office/drawing/2014/main" val="1832017480"/>
                    </a:ext>
                  </a:extLst>
                </a:gridCol>
                <a:gridCol w="636339">
                  <a:extLst>
                    <a:ext uri="{9D8B030D-6E8A-4147-A177-3AD203B41FA5}">
                      <a16:colId xmlns:a16="http://schemas.microsoft.com/office/drawing/2014/main" val="3413821705"/>
                    </a:ext>
                  </a:extLst>
                </a:gridCol>
                <a:gridCol w="636339">
                  <a:extLst>
                    <a:ext uri="{9D8B030D-6E8A-4147-A177-3AD203B41FA5}">
                      <a16:colId xmlns:a16="http://schemas.microsoft.com/office/drawing/2014/main" val="4125518172"/>
                    </a:ext>
                  </a:extLst>
                </a:gridCol>
                <a:gridCol w="636339">
                  <a:extLst>
                    <a:ext uri="{9D8B030D-6E8A-4147-A177-3AD203B41FA5}">
                      <a16:colId xmlns:a16="http://schemas.microsoft.com/office/drawing/2014/main" val="3955119549"/>
                    </a:ext>
                  </a:extLst>
                </a:gridCol>
                <a:gridCol w="776702">
                  <a:extLst>
                    <a:ext uri="{9D8B030D-6E8A-4147-A177-3AD203B41FA5}">
                      <a16:colId xmlns:a16="http://schemas.microsoft.com/office/drawing/2014/main" val="1127966879"/>
                    </a:ext>
                  </a:extLst>
                </a:gridCol>
                <a:gridCol w="636339">
                  <a:extLst>
                    <a:ext uri="{9D8B030D-6E8A-4147-A177-3AD203B41FA5}">
                      <a16:colId xmlns:a16="http://schemas.microsoft.com/office/drawing/2014/main" val="3343433349"/>
                    </a:ext>
                  </a:extLst>
                </a:gridCol>
                <a:gridCol w="662854">
                  <a:extLst>
                    <a:ext uri="{9D8B030D-6E8A-4147-A177-3AD203B41FA5}">
                      <a16:colId xmlns:a16="http://schemas.microsoft.com/office/drawing/2014/main" val="2293106254"/>
                    </a:ext>
                  </a:extLst>
                </a:gridCol>
              </a:tblGrid>
              <a:tr h="168200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riant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r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ition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A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A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AF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TA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lang="en" sz="105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" sz="105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" sz="1050" u="none" strike="noStrike" baseline="-25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terogeneity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8458208"/>
                  </a:ext>
                </a:extLst>
              </a:tr>
              <a:tr h="168200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s674345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,894,934 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9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9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392010206"/>
                  </a:ext>
                </a:extLst>
              </a:tr>
              <a:tr h="168200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4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extLst>
                  <a:ext uri="{0D108BD9-81ED-4DB2-BD59-A6C34878D82A}">
                    <a16:rowId xmlns:a16="http://schemas.microsoft.com/office/drawing/2014/main" val="2907037638"/>
                  </a:ext>
                </a:extLst>
              </a:tr>
              <a:tr h="16820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.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2047520"/>
                  </a:ext>
                </a:extLst>
              </a:tr>
              <a:tr h="168200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s237837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,841,641 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62603220"/>
                  </a:ext>
                </a:extLst>
              </a:tr>
              <a:tr h="168200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extLst>
                  <a:ext uri="{0D108BD9-81ED-4DB2-BD59-A6C34878D82A}">
                    <a16:rowId xmlns:a16="http://schemas.microsoft.com/office/drawing/2014/main" val="2413773849"/>
                  </a:ext>
                </a:extLst>
              </a:tr>
              <a:tr h="16820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9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.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7934072"/>
                  </a:ext>
                </a:extLst>
              </a:tr>
              <a:tr h="168200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s4410790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,284,577 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701610479"/>
                  </a:ext>
                </a:extLst>
              </a:tr>
              <a:tr h="168200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9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7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extLst>
                  <a:ext uri="{0D108BD9-81ED-4DB2-BD59-A6C34878D82A}">
                    <a16:rowId xmlns:a16="http://schemas.microsoft.com/office/drawing/2014/main" val="2368954737"/>
                  </a:ext>
                </a:extLst>
              </a:tr>
              <a:tr h="27612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9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6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8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4972575"/>
                  </a:ext>
                </a:extLst>
              </a:tr>
              <a:tr h="276128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s11066015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2,168,009 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223495969"/>
                  </a:ext>
                </a:extLst>
              </a:tr>
              <a:tr h="168200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/>
                </a:tc>
                <a:extLst>
                  <a:ext uri="{0D108BD9-81ED-4DB2-BD59-A6C34878D82A}">
                    <a16:rowId xmlns:a16="http://schemas.microsoft.com/office/drawing/2014/main" val="3731191425"/>
                  </a:ext>
                </a:extLst>
              </a:tr>
              <a:tr h="27612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3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.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008" marR="7008" marT="70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586026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099554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9" name="テキスト ボックス 208"/>
          <p:cNvSpPr txBox="1"/>
          <p:nvPr/>
        </p:nvSpPr>
        <p:spPr>
          <a:xfrm>
            <a:off x="129332" y="299908"/>
            <a:ext cx="65482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ea typeface="Osaka" charset="-128"/>
                <a:cs typeface="Times New Roman" panose="02020603050405020304" pitchFamily="18" charset="0"/>
              </a:rPr>
              <a:t>Table </a:t>
            </a:r>
            <a:r>
              <a:rPr lang="en-US" altLang="ja-JP" sz="1200" dirty="0">
                <a:latin typeface="Times New Roman" panose="02020603050405020304" pitchFamily="18" charset="0"/>
                <a:ea typeface="Osaka" charset="-128"/>
                <a:cs typeface="Times New Roman" panose="02020603050405020304" pitchFamily="18" charset="0"/>
              </a:rPr>
              <a:t>S3. Results of genome-wide association analysis based </a:t>
            </a:r>
            <a:r>
              <a:rPr lang="en-US" altLang="ja-JP" sz="1200">
                <a:latin typeface="Times New Roman" panose="02020603050405020304" pitchFamily="18" charset="0"/>
                <a:ea typeface="Osaka" charset="-128"/>
                <a:cs typeface="Times New Roman" panose="02020603050405020304" pitchFamily="18" charset="0"/>
              </a:rPr>
              <a:t>on </a:t>
            </a:r>
            <a:r>
              <a:rPr lang="en-US" altLang="ja-JP" sz="1200" smtClean="0">
                <a:latin typeface="Times New Roman" panose="02020603050405020304" pitchFamily="18" charset="0"/>
                <a:ea typeface="Osaka" charset="-128"/>
                <a:cs typeface="Times New Roman" panose="02020603050405020304" pitchFamily="18" charset="0"/>
              </a:rPr>
              <a:t>a recessive </a:t>
            </a:r>
            <a:r>
              <a:rPr lang="en-US" altLang="ja-JP" sz="1200" dirty="0">
                <a:latin typeface="Times New Roman" panose="02020603050405020304" pitchFamily="18" charset="0"/>
                <a:ea typeface="Osaka" charset="-128"/>
                <a:cs typeface="Times New Roman" panose="02020603050405020304" pitchFamily="18" charset="0"/>
              </a:rPr>
              <a:t>model</a:t>
            </a:r>
            <a:endParaRPr lang="ja-JP" altLang="en-US" sz="1200" dirty="0">
              <a:latin typeface="Times New Roman" panose="02020603050405020304" pitchFamily="18" charset="0"/>
              <a:ea typeface="Osaka" charset="-128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E1129EA-9B1E-AA45-BF74-3E52BA3C76E7}"/>
              </a:ext>
            </a:extLst>
          </p:cNvPr>
          <p:cNvSpPr txBox="1"/>
          <p:nvPr/>
        </p:nvSpPr>
        <p:spPr>
          <a:xfrm>
            <a:off x="129333" y="4139938"/>
            <a:ext cx="6612036" cy="475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46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, chromosome; EA, effect allele; NEA, non-effect allele; EAF, effect allele frequency; SE, standard error</a:t>
            </a:r>
            <a:endParaRPr lang="ja-JP" altLang="en-US" sz="124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047404BA-73C7-FD4F-985C-173B8921214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08954277"/>
              </p:ext>
            </p:extLst>
          </p:nvPr>
        </p:nvGraphicFramePr>
        <p:xfrm>
          <a:off x="129332" y="683568"/>
          <a:ext cx="6548282" cy="3422907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804432">
                  <a:extLst>
                    <a:ext uri="{9D8B030D-6E8A-4147-A177-3AD203B41FA5}">
                      <a16:colId xmlns:a16="http://schemas.microsoft.com/office/drawing/2014/main" val="994308009"/>
                    </a:ext>
                  </a:extLst>
                </a:gridCol>
                <a:gridCol w="285428">
                  <a:extLst>
                    <a:ext uri="{9D8B030D-6E8A-4147-A177-3AD203B41FA5}">
                      <a16:colId xmlns:a16="http://schemas.microsoft.com/office/drawing/2014/main" val="1785071908"/>
                    </a:ext>
                  </a:extLst>
                </a:gridCol>
                <a:gridCol w="861891">
                  <a:extLst>
                    <a:ext uri="{9D8B030D-6E8A-4147-A177-3AD203B41FA5}">
                      <a16:colId xmlns:a16="http://schemas.microsoft.com/office/drawing/2014/main" val="3120333043"/>
                    </a:ext>
                  </a:extLst>
                </a:gridCol>
                <a:gridCol w="310281">
                  <a:extLst>
                    <a:ext uri="{9D8B030D-6E8A-4147-A177-3AD203B41FA5}">
                      <a16:colId xmlns:a16="http://schemas.microsoft.com/office/drawing/2014/main" val="178023781"/>
                    </a:ext>
                  </a:extLst>
                </a:gridCol>
                <a:gridCol w="425200">
                  <a:extLst>
                    <a:ext uri="{9D8B030D-6E8A-4147-A177-3AD203B41FA5}">
                      <a16:colId xmlns:a16="http://schemas.microsoft.com/office/drawing/2014/main" val="1539197306"/>
                    </a:ext>
                  </a:extLst>
                </a:gridCol>
                <a:gridCol w="620561">
                  <a:extLst>
                    <a:ext uri="{9D8B030D-6E8A-4147-A177-3AD203B41FA5}">
                      <a16:colId xmlns:a16="http://schemas.microsoft.com/office/drawing/2014/main" val="2794939286"/>
                    </a:ext>
                  </a:extLst>
                </a:gridCol>
                <a:gridCol w="620561">
                  <a:extLst>
                    <a:ext uri="{9D8B030D-6E8A-4147-A177-3AD203B41FA5}">
                      <a16:colId xmlns:a16="http://schemas.microsoft.com/office/drawing/2014/main" val="2851943752"/>
                    </a:ext>
                  </a:extLst>
                </a:gridCol>
                <a:gridCol w="620561">
                  <a:extLst>
                    <a:ext uri="{9D8B030D-6E8A-4147-A177-3AD203B41FA5}">
                      <a16:colId xmlns:a16="http://schemas.microsoft.com/office/drawing/2014/main" val="2863221348"/>
                    </a:ext>
                  </a:extLst>
                </a:gridCol>
                <a:gridCol w="732388">
                  <a:extLst>
                    <a:ext uri="{9D8B030D-6E8A-4147-A177-3AD203B41FA5}">
                      <a16:colId xmlns:a16="http://schemas.microsoft.com/office/drawing/2014/main" val="1311369960"/>
                    </a:ext>
                  </a:extLst>
                </a:gridCol>
                <a:gridCol w="620561">
                  <a:extLst>
                    <a:ext uri="{9D8B030D-6E8A-4147-A177-3AD203B41FA5}">
                      <a16:colId xmlns:a16="http://schemas.microsoft.com/office/drawing/2014/main" val="854776380"/>
                    </a:ext>
                  </a:extLst>
                </a:gridCol>
                <a:gridCol w="646418">
                  <a:extLst>
                    <a:ext uri="{9D8B030D-6E8A-4147-A177-3AD203B41FA5}">
                      <a16:colId xmlns:a16="http://schemas.microsoft.com/office/drawing/2014/main" val="3543709207"/>
                    </a:ext>
                  </a:extLst>
                </a:gridCol>
              </a:tblGrid>
              <a:tr h="180153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riant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r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P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A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A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AF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TA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lang="en" sz="105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" sz="105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" sz="1050" u="none" strike="noStrike" baseline="-25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terogeneity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9399687"/>
                  </a:ext>
                </a:extLst>
              </a:tr>
              <a:tr h="180153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s11264164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,966,914 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1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3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442706858"/>
                  </a:ext>
                </a:extLst>
              </a:tr>
              <a:tr h="180153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1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extLst>
                  <a:ext uri="{0D108BD9-81ED-4DB2-BD59-A6C34878D82A}">
                    <a16:rowId xmlns:a16="http://schemas.microsoft.com/office/drawing/2014/main" val="2246474631"/>
                  </a:ext>
                </a:extLst>
              </a:tr>
              <a:tr h="18015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1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9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.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3862389"/>
                  </a:ext>
                </a:extLst>
              </a:tr>
              <a:tr h="180153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s10194179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3,097,848 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9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2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641845451"/>
                  </a:ext>
                </a:extLst>
              </a:tr>
              <a:tr h="180153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extLst>
                  <a:ext uri="{0D108BD9-81ED-4DB2-BD59-A6C34878D82A}">
                    <a16:rowId xmlns:a16="http://schemas.microsoft.com/office/drawing/2014/main" val="2002418774"/>
                  </a:ext>
                </a:extLst>
              </a:tr>
              <a:tr h="18015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3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5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.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3038467"/>
                  </a:ext>
                </a:extLst>
              </a:tr>
              <a:tr h="180153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s11747048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,166,100 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0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4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209449969"/>
                  </a:ext>
                </a:extLst>
              </a:tr>
              <a:tr h="180153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2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6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extLst>
                  <a:ext uri="{0D108BD9-81ED-4DB2-BD59-A6C34878D82A}">
                    <a16:rowId xmlns:a16="http://schemas.microsoft.com/office/drawing/2014/main" val="3065885645"/>
                  </a:ext>
                </a:extLst>
              </a:tr>
              <a:tr h="18015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6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49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.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0668870"/>
                  </a:ext>
                </a:extLst>
              </a:tr>
              <a:tr h="180153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s6455762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2,133,154 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3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6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653986042"/>
                  </a:ext>
                </a:extLst>
              </a:tr>
              <a:tr h="180153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extLst>
                  <a:ext uri="{0D108BD9-81ED-4DB2-BD59-A6C34878D82A}">
                    <a16:rowId xmlns:a16="http://schemas.microsoft.com/office/drawing/2014/main" val="1686586182"/>
                  </a:ext>
                </a:extLst>
              </a:tr>
              <a:tr h="18015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9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99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6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.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5024353"/>
                  </a:ext>
                </a:extLst>
              </a:tr>
              <a:tr h="180153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s12148784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,900,775 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7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3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3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102379060"/>
                  </a:ext>
                </a:extLst>
              </a:tr>
              <a:tr h="180153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94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extLst>
                  <a:ext uri="{0D108BD9-81ED-4DB2-BD59-A6C34878D82A}">
                    <a16:rowId xmlns:a16="http://schemas.microsoft.com/office/drawing/2014/main" val="1602547152"/>
                  </a:ext>
                </a:extLst>
              </a:tr>
              <a:tr h="18015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9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.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3985372"/>
                  </a:ext>
                </a:extLst>
              </a:tr>
              <a:tr h="180153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s8121071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,428,769 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81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7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285011066"/>
                  </a:ext>
                </a:extLst>
              </a:tr>
              <a:tr h="180153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28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6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/>
                </a:tc>
                <a:extLst>
                  <a:ext uri="{0D108BD9-81ED-4DB2-BD59-A6C34878D82A}">
                    <a16:rowId xmlns:a16="http://schemas.microsoft.com/office/drawing/2014/main" val="250972434"/>
                  </a:ext>
                </a:extLst>
              </a:tr>
              <a:tr h="18015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3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3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5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6 × 10</a:t>
                      </a:r>
                      <a:r>
                        <a:rPr lang="ja-JP" altLang="en-US" sz="105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05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506" marR="7506" marT="7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890218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042837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9" name="テキスト ボックス 208"/>
          <p:cNvSpPr txBox="1"/>
          <p:nvPr/>
        </p:nvSpPr>
        <p:spPr>
          <a:xfrm>
            <a:off x="129332" y="299908"/>
            <a:ext cx="65482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ea typeface="Osaka" charset="-128"/>
                <a:cs typeface="Times New Roman" panose="02020603050405020304" pitchFamily="18" charset="0"/>
              </a:rPr>
              <a:t>Table </a:t>
            </a:r>
            <a:r>
              <a:rPr lang="en-US" altLang="ja-JP" sz="1200" dirty="0">
                <a:latin typeface="Times New Roman" panose="02020603050405020304" pitchFamily="18" charset="0"/>
                <a:ea typeface="Osaka" charset="-128"/>
                <a:cs typeface="Times New Roman" panose="02020603050405020304" pitchFamily="18" charset="0"/>
              </a:rPr>
              <a:t>S4. Adjustment for potential confounding factors</a:t>
            </a:r>
            <a:endParaRPr lang="ja-JP" altLang="en-US" sz="1200" dirty="0">
              <a:latin typeface="Times New Roman" panose="02020603050405020304" pitchFamily="18" charset="0"/>
              <a:ea typeface="Osaka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DC4E93D2-6BB5-F549-B653-BC73AE140FEE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238245" y="686199"/>
          <a:ext cx="6439371" cy="216158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822397">
                  <a:extLst>
                    <a:ext uri="{9D8B030D-6E8A-4147-A177-3AD203B41FA5}">
                      <a16:colId xmlns:a16="http://schemas.microsoft.com/office/drawing/2014/main" val="3795837385"/>
                    </a:ext>
                  </a:extLst>
                </a:gridCol>
                <a:gridCol w="3092215">
                  <a:extLst>
                    <a:ext uri="{9D8B030D-6E8A-4147-A177-3AD203B41FA5}">
                      <a16:colId xmlns:a16="http://schemas.microsoft.com/office/drawing/2014/main" val="476979340"/>
                    </a:ext>
                  </a:extLst>
                </a:gridCol>
                <a:gridCol w="822397">
                  <a:extLst>
                    <a:ext uri="{9D8B030D-6E8A-4147-A177-3AD203B41FA5}">
                      <a16:colId xmlns:a16="http://schemas.microsoft.com/office/drawing/2014/main" val="383499239"/>
                    </a:ext>
                  </a:extLst>
                </a:gridCol>
                <a:gridCol w="822397">
                  <a:extLst>
                    <a:ext uri="{9D8B030D-6E8A-4147-A177-3AD203B41FA5}">
                      <a16:colId xmlns:a16="http://schemas.microsoft.com/office/drawing/2014/main" val="924088237"/>
                    </a:ext>
                  </a:extLst>
                </a:gridCol>
                <a:gridCol w="879965">
                  <a:extLst>
                    <a:ext uri="{9D8B030D-6E8A-4147-A177-3AD203B41FA5}">
                      <a16:colId xmlns:a16="http://schemas.microsoft.com/office/drawing/2014/main" val="763233459"/>
                    </a:ext>
                  </a:extLst>
                </a:gridCol>
              </a:tblGrid>
              <a:tr h="196508"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P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justment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ta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(Beta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lang="en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8097716"/>
                  </a:ext>
                </a:extLst>
              </a:tr>
              <a:tr h="196508">
                <a:tc>
                  <a:txBody>
                    <a:bodyPr/>
                    <a:lstStyle/>
                    <a:p>
                      <a:pPr algn="l" fontAlgn="ctr"/>
                      <a:r>
                        <a:rPr lang="e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s10252701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, Sex, Site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-0.149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02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.1 × 10</a:t>
                      </a:r>
                      <a:r>
                        <a:rPr lang="ja-JP" altLang="en-US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−</a:t>
                      </a:r>
                      <a:r>
                        <a:rPr lang="en-US" altLang="ja-JP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3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217959260"/>
                  </a:ext>
                </a:extLst>
              </a:tr>
              <a:tr h="196508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, Sex, Site, BMI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-0.15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02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.1 × 10</a:t>
                      </a:r>
                      <a:r>
                        <a:rPr lang="ja-JP" altLang="en-US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−</a:t>
                      </a:r>
                      <a:r>
                        <a:rPr lang="en-US" altLang="ja-JP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3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77282509"/>
                  </a:ext>
                </a:extLst>
              </a:tr>
              <a:tr h="196508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, Sex, Site, alcohol consumption (g/week)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-0.149</a:t>
                      </a:r>
                    </a:p>
                  </a:txBody>
                  <a:tcPr marL="9525" marR="9525" marT="9525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020</a:t>
                      </a:r>
                    </a:p>
                  </a:txBody>
                  <a:tcPr marL="9525" marR="9525" marT="9525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.5 × 10</a:t>
                      </a:r>
                      <a:r>
                        <a:rPr lang="ja-JP" altLang="en-US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−</a:t>
                      </a:r>
                      <a:r>
                        <a:rPr lang="en-US" altLang="ja-JP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3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2687059"/>
                  </a:ext>
                </a:extLst>
              </a:tr>
              <a:tr h="19650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, Sex, Site, alcohol frequency (day/week)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-0.15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0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.0 × 10</a:t>
                      </a:r>
                      <a:r>
                        <a:rPr lang="ja-JP" altLang="en-US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−</a:t>
                      </a:r>
                      <a:r>
                        <a:rPr lang="en-US" altLang="ja-JP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3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50439220"/>
                  </a:ext>
                </a:extLst>
              </a:tr>
              <a:tr h="196508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Age, Sex, Site, Smoking status</a:t>
                      </a:r>
                    </a:p>
                  </a:txBody>
                  <a:tcPr marL="6594" marR="6594" marT="6594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-0.149</a:t>
                      </a:r>
                    </a:p>
                  </a:txBody>
                  <a:tcPr marL="9525" marR="9525" marT="952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020</a:t>
                      </a:r>
                    </a:p>
                  </a:txBody>
                  <a:tcPr marL="9525" marR="9525" marT="952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4.3 × 10</a:t>
                      </a:r>
                      <a:r>
                        <a:rPr lang="ja-JP" altLang="en-US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−</a:t>
                      </a:r>
                      <a:r>
                        <a:rPr lang="en-US" altLang="ja-JP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4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4227107"/>
                  </a:ext>
                </a:extLst>
              </a:tr>
              <a:tr h="196508">
                <a:tc>
                  <a:txBody>
                    <a:bodyPr/>
                    <a:lstStyle/>
                    <a:p>
                      <a:pPr algn="l" fontAlgn="ctr"/>
                      <a:r>
                        <a:rPr lang="e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s79105258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, Sex, Site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167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02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8.3 × 10</a:t>
                      </a:r>
                      <a:r>
                        <a:rPr lang="ja-JP" altLang="en-US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−</a:t>
                      </a:r>
                      <a:r>
                        <a:rPr lang="en-US" altLang="ja-JP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5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01455172"/>
                  </a:ext>
                </a:extLst>
              </a:tr>
              <a:tr h="196508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, Sex, Site, BMI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17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021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2.5 × 10</a:t>
                      </a:r>
                      <a:r>
                        <a:rPr lang="ja-JP" altLang="en-US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−</a:t>
                      </a:r>
                      <a:r>
                        <a:rPr lang="en-US" altLang="ja-JP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5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6992914"/>
                  </a:ext>
                </a:extLst>
              </a:tr>
              <a:tr h="196508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, Sex, Site, alcohol consumption (g/week)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168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022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4.1 × 10</a:t>
                      </a:r>
                      <a:r>
                        <a:rPr lang="ja-JP" altLang="en-US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−</a:t>
                      </a:r>
                      <a:r>
                        <a:rPr lang="en-US" altLang="ja-JP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4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8060944"/>
                  </a:ext>
                </a:extLst>
              </a:tr>
              <a:tr h="19650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, Sex, Site, alcohol frequency (day/week)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193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023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.4 × 10</a:t>
                      </a:r>
                      <a:r>
                        <a:rPr lang="ja-JP" altLang="en-US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−</a:t>
                      </a:r>
                      <a:r>
                        <a:rPr lang="en-US" altLang="ja-JP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7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4803225"/>
                  </a:ext>
                </a:extLst>
              </a:tr>
              <a:tr h="196508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Age, Sex, Site, Smoking status</a:t>
                      </a:r>
                    </a:p>
                  </a:txBody>
                  <a:tcPr marL="6594" marR="6594" marT="65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166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02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.7 × 10</a:t>
                      </a:r>
                      <a:r>
                        <a:rPr lang="ja-JP" altLang="en-US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−</a:t>
                      </a:r>
                      <a:r>
                        <a:rPr lang="en-US" altLang="ja-JP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5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31803605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E1129EA-9B1E-AA45-BF74-3E52BA3C76E7}"/>
              </a:ext>
            </a:extLst>
          </p:cNvPr>
          <p:cNvSpPr txBox="1"/>
          <p:nvPr/>
        </p:nvSpPr>
        <p:spPr>
          <a:xfrm>
            <a:off x="238245" y="2847788"/>
            <a:ext cx="5201296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46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oking status was either of current smoker, former smoker, or never smoker.</a:t>
            </a:r>
            <a:endParaRPr lang="ja-JP" altLang="en-US" sz="124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08756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9" name="テキスト ボックス 208"/>
          <p:cNvSpPr txBox="1"/>
          <p:nvPr/>
        </p:nvSpPr>
        <p:spPr>
          <a:xfrm>
            <a:off x="-219953" y="354768"/>
            <a:ext cx="7200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 smtClean="0">
                <a:latin typeface="Times New Roman" panose="02020603050405020304" pitchFamily="18" charset="0"/>
                <a:ea typeface="Osaka" charset="-128"/>
                <a:cs typeface="Times New Roman" panose="02020603050405020304" pitchFamily="18" charset="0"/>
              </a:rPr>
              <a:t>Table S5. </a:t>
            </a:r>
            <a:r>
              <a:rPr lang="en-US" altLang="ja-JP" sz="1200" dirty="0">
                <a:latin typeface="Times New Roman" panose="02020603050405020304" pitchFamily="18" charset="0"/>
                <a:ea typeface="Osaka" charset="-128"/>
                <a:cs typeface="Times New Roman" panose="02020603050405020304" pitchFamily="18" charset="0"/>
              </a:rPr>
              <a:t>Pleiotropic effects with adjustment for age, sex, cohort region, and alcohol consumption</a:t>
            </a:r>
            <a:endParaRPr lang="ja-JP" altLang="en-US" sz="1200" dirty="0">
              <a:latin typeface="Times New Roman" panose="02020603050405020304" pitchFamily="18" charset="0"/>
              <a:ea typeface="Osaka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A04E8AE9-4BC1-6742-BEAB-F643F9E973A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88662370"/>
              </p:ext>
            </p:extLst>
          </p:nvPr>
        </p:nvGraphicFramePr>
        <p:xfrm>
          <a:off x="374382" y="717975"/>
          <a:ext cx="6012130" cy="1328517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92374">
                  <a:extLst>
                    <a:ext uri="{9D8B030D-6E8A-4147-A177-3AD203B41FA5}">
                      <a16:colId xmlns:a16="http://schemas.microsoft.com/office/drawing/2014/main" val="1728980232"/>
                    </a:ext>
                  </a:extLst>
                </a:gridCol>
                <a:gridCol w="826978">
                  <a:extLst>
                    <a:ext uri="{9D8B030D-6E8A-4147-A177-3AD203B41FA5}">
                      <a16:colId xmlns:a16="http://schemas.microsoft.com/office/drawing/2014/main" val="821299041"/>
                    </a:ext>
                  </a:extLst>
                </a:gridCol>
                <a:gridCol w="826978">
                  <a:extLst>
                    <a:ext uri="{9D8B030D-6E8A-4147-A177-3AD203B41FA5}">
                      <a16:colId xmlns:a16="http://schemas.microsoft.com/office/drawing/2014/main" val="838146211"/>
                    </a:ext>
                  </a:extLst>
                </a:gridCol>
                <a:gridCol w="826978">
                  <a:extLst>
                    <a:ext uri="{9D8B030D-6E8A-4147-A177-3AD203B41FA5}">
                      <a16:colId xmlns:a16="http://schemas.microsoft.com/office/drawing/2014/main" val="14665357"/>
                    </a:ext>
                  </a:extLst>
                </a:gridCol>
                <a:gridCol w="57888">
                  <a:extLst>
                    <a:ext uri="{9D8B030D-6E8A-4147-A177-3AD203B41FA5}">
                      <a16:colId xmlns:a16="http://schemas.microsoft.com/office/drawing/2014/main" val="2078086608"/>
                    </a:ext>
                  </a:extLst>
                </a:gridCol>
                <a:gridCol w="826978">
                  <a:extLst>
                    <a:ext uri="{9D8B030D-6E8A-4147-A177-3AD203B41FA5}">
                      <a16:colId xmlns:a16="http://schemas.microsoft.com/office/drawing/2014/main" val="2707673986"/>
                    </a:ext>
                  </a:extLst>
                </a:gridCol>
                <a:gridCol w="826978">
                  <a:extLst>
                    <a:ext uri="{9D8B030D-6E8A-4147-A177-3AD203B41FA5}">
                      <a16:colId xmlns:a16="http://schemas.microsoft.com/office/drawing/2014/main" val="1980338247"/>
                    </a:ext>
                  </a:extLst>
                </a:gridCol>
                <a:gridCol w="826978">
                  <a:extLst>
                    <a:ext uri="{9D8B030D-6E8A-4147-A177-3AD203B41FA5}">
                      <a16:colId xmlns:a16="http://schemas.microsoft.com/office/drawing/2014/main" val="3766150878"/>
                    </a:ext>
                  </a:extLst>
                </a:gridCol>
              </a:tblGrid>
              <a:tr h="175407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s10252701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s79105258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96649725"/>
                  </a:ext>
                </a:extLst>
              </a:tr>
              <a:tr h="175407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ta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(Beta)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lang="en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ta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(Beta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lang="en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372672"/>
                  </a:ext>
                </a:extLst>
              </a:tr>
              <a:tr h="175407">
                <a:tc>
                  <a:txBody>
                    <a:bodyPr/>
                    <a:lstStyle/>
                    <a:p>
                      <a:pPr algn="l" fontAlgn="ctr"/>
                      <a:r>
                        <a:rPr lang="e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MI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018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049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7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　</a:t>
                      </a: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-0.167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05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1 × 10</a:t>
                      </a:r>
                      <a:r>
                        <a:rPr lang="ja-JP" altLang="en-US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129486989"/>
                  </a:ext>
                </a:extLst>
              </a:tr>
              <a:tr h="175407">
                <a:tc>
                  <a:txBody>
                    <a:bodyPr/>
                    <a:lstStyle/>
                    <a:p>
                      <a:pPr algn="l" fontAlgn="ctr"/>
                      <a:r>
                        <a:rPr lang="e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cholesterol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-0.7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63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2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　</a:t>
                      </a:r>
                    </a:p>
                  </a:txBody>
                  <a:tcPr marL="6594" marR="6594" marT="65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65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70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35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77473424"/>
                  </a:ext>
                </a:extLst>
              </a:tr>
              <a:tr h="175407">
                <a:tc>
                  <a:txBody>
                    <a:bodyPr/>
                    <a:lstStyle/>
                    <a:p>
                      <a:pPr algn="l" fontAlgn="ctr"/>
                      <a:r>
                        <a:rPr lang="e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yglecerid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-0.18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88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8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　</a:t>
                      </a:r>
                    </a:p>
                  </a:txBody>
                  <a:tcPr marL="6594" marR="6594" marT="65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-2.5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98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01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87581450"/>
                  </a:ext>
                </a:extLst>
              </a:tr>
              <a:tr h="175407">
                <a:tc>
                  <a:txBody>
                    <a:bodyPr/>
                    <a:lstStyle/>
                    <a:p>
                      <a:pPr algn="l" fontAlgn="ctr"/>
                      <a:r>
                        <a:rPr lang="e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bA1c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016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01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1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　</a:t>
                      </a:r>
                    </a:p>
                  </a:txBody>
                  <a:tcPr marL="6594" marR="6594" marT="65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-0.013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01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29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2337208"/>
                  </a:ext>
                </a:extLst>
              </a:tr>
            </a:tbl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9D16E5E-E253-E842-8233-8E29E2C80C94}"/>
              </a:ext>
            </a:extLst>
          </p:cNvPr>
          <p:cNvSpPr txBox="1"/>
          <p:nvPr/>
        </p:nvSpPr>
        <p:spPr>
          <a:xfrm>
            <a:off x="374382" y="2076923"/>
            <a:ext cx="2589170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I, body-mass index; SE, standard error</a:t>
            </a:r>
            <a:endParaRPr lang="ja-JP" altLang="en-US" sz="1108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1" name="表 10">
            <a:extLst>
              <a:ext uri="{FF2B5EF4-FFF2-40B4-BE49-F238E27FC236}">
                <a16:creationId xmlns:a16="http://schemas.microsoft.com/office/drawing/2014/main" id="{A595EA22-0A93-3A46-9525-D03AF4AE65F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47648144"/>
              </p:ext>
            </p:extLst>
          </p:nvPr>
        </p:nvGraphicFramePr>
        <p:xfrm>
          <a:off x="374382" y="3098245"/>
          <a:ext cx="6012130" cy="1328517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92374">
                  <a:extLst>
                    <a:ext uri="{9D8B030D-6E8A-4147-A177-3AD203B41FA5}">
                      <a16:colId xmlns:a16="http://schemas.microsoft.com/office/drawing/2014/main" val="1728980232"/>
                    </a:ext>
                  </a:extLst>
                </a:gridCol>
                <a:gridCol w="826978">
                  <a:extLst>
                    <a:ext uri="{9D8B030D-6E8A-4147-A177-3AD203B41FA5}">
                      <a16:colId xmlns:a16="http://schemas.microsoft.com/office/drawing/2014/main" val="821299041"/>
                    </a:ext>
                  </a:extLst>
                </a:gridCol>
                <a:gridCol w="826978">
                  <a:extLst>
                    <a:ext uri="{9D8B030D-6E8A-4147-A177-3AD203B41FA5}">
                      <a16:colId xmlns:a16="http://schemas.microsoft.com/office/drawing/2014/main" val="838146211"/>
                    </a:ext>
                  </a:extLst>
                </a:gridCol>
                <a:gridCol w="826978">
                  <a:extLst>
                    <a:ext uri="{9D8B030D-6E8A-4147-A177-3AD203B41FA5}">
                      <a16:colId xmlns:a16="http://schemas.microsoft.com/office/drawing/2014/main" val="14665357"/>
                    </a:ext>
                  </a:extLst>
                </a:gridCol>
                <a:gridCol w="57888">
                  <a:extLst>
                    <a:ext uri="{9D8B030D-6E8A-4147-A177-3AD203B41FA5}">
                      <a16:colId xmlns:a16="http://schemas.microsoft.com/office/drawing/2014/main" val="2078086608"/>
                    </a:ext>
                  </a:extLst>
                </a:gridCol>
                <a:gridCol w="826978">
                  <a:extLst>
                    <a:ext uri="{9D8B030D-6E8A-4147-A177-3AD203B41FA5}">
                      <a16:colId xmlns:a16="http://schemas.microsoft.com/office/drawing/2014/main" val="2707673986"/>
                    </a:ext>
                  </a:extLst>
                </a:gridCol>
                <a:gridCol w="826978">
                  <a:extLst>
                    <a:ext uri="{9D8B030D-6E8A-4147-A177-3AD203B41FA5}">
                      <a16:colId xmlns:a16="http://schemas.microsoft.com/office/drawing/2014/main" val="1980338247"/>
                    </a:ext>
                  </a:extLst>
                </a:gridCol>
                <a:gridCol w="826978">
                  <a:extLst>
                    <a:ext uri="{9D8B030D-6E8A-4147-A177-3AD203B41FA5}">
                      <a16:colId xmlns:a16="http://schemas.microsoft.com/office/drawing/2014/main" val="3766150878"/>
                    </a:ext>
                  </a:extLst>
                </a:gridCol>
              </a:tblGrid>
              <a:tr h="175407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s10252701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s79105258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96649725"/>
                  </a:ext>
                </a:extLst>
              </a:tr>
              <a:tr h="175407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ta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(Beta)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lang="en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ta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(Beta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lang="en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372672"/>
                  </a:ext>
                </a:extLst>
              </a:tr>
              <a:tr h="175407">
                <a:tc>
                  <a:txBody>
                    <a:bodyPr/>
                    <a:lstStyle/>
                    <a:p>
                      <a:pPr algn="l" fontAlgn="ctr"/>
                      <a:r>
                        <a:rPr lang="e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MI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026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049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6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　</a:t>
                      </a:r>
                    </a:p>
                  </a:txBody>
                  <a:tcPr marL="6594" marR="6594" marT="65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-0.32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05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9 × 10</a:t>
                      </a:r>
                      <a:r>
                        <a:rPr lang="ja-JP" altLang="en-US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9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129486989"/>
                  </a:ext>
                </a:extLst>
              </a:tr>
              <a:tr h="175407">
                <a:tc>
                  <a:txBody>
                    <a:bodyPr/>
                    <a:lstStyle/>
                    <a:p>
                      <a:pPr algn="l" fontAlgn="ctr"/>
                      <a:r>
                        <a:rPr lang="e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cholesterol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-0.7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63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2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　</a:t>
                      </a:r>
                    </a:p>
                  </a:txBody>
                  <a:tcPr marL="6594" marR="6594" marT="65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33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7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6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77473424"/>
                  </a:ext>
                </a:extLst>
              </a:tr>
              <a:tr h="175407">
                <a:tc>
                  <a:txBody>
                    <a:bodyPr/>
                    <a:lstStyle/>
                    <a:p>
                      <a:pPr algn="l" fontAlgn="ctr"/>
                      <a:r>
                        <a:rPr lang="e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yglecerid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-0.16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88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8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　</a:t>
                      </a:r>
                    </a:p>
                  </a:txBody>
                  <a:tcPr marL="6594" marR="6594" marT="65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-3.45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00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5.7 × 10</a:t>
                      </a:r>
                      <a:r>
                        <a:rPr lang="ja-JP" altLang="en-US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87581450"/>
                  </a:ext>
                </a:extLst>
              </a:tr>
              <a:tr h="175407">
                <a:tc>
                  <a:txBody>
                    <a:bodyPr/>
                    <a:lstStyle/>
                    <a:p>
                      <a:pPr algn="l" fontAlgn="ctr"/>
                      <a:r>
                        <a:rPr lang="e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bA1c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594" marR="6594" marT="65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016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01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0.1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　</a:t>
                      </a:r>
                    </a:p>
                  </a:txBody>
                  <a:tcPr marL="6594" marR="6594" marT="65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-0.02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01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06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2337208"/>
                  </a:ext>
                </a:extLst>
              </a:tr>
            </a:tbl>
          </a:graphicData>
        </a:graphic>
      </p:graphicFrame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59E7718-9E46-B848-B414-C9CB4B785B99}"/>
              </a:ext>
            </a:extLst>
          </p:cNvPr>
          <p:cNvSpPr txBox="1"/>
          <p:nvPr/>
        </p:nvSpPr>
        <p:spPr>
          <a:xfrm>
            <a:off x="374382" y="4453187"/>
            <a:ext cx="2589170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I, body-mass index; SE, standard error</a:t>
            </a:r>
            <a:endParaRPr lang="ja-JP" altLang="en-US" sz="1108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9FBC0E4-8D5E-264B-B003-9A4E35DF5A91}"/>
              </a:ext>
            </a:extLst>
          </p:cNvPr>
          <p:cNvSpPr txBox="1"/>
          <p:nvPr/>
        </p:nvSpPr>
        <p:spPr>
          <a:xfrm>
            <a:off x="-219953" y="2809536"/>
            <a:ext cx="7200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 smtClean="0">
                <a:latin typeface="Times New Roman" panose="02020603050405020304" pitchFamily="18" charset="0"/>
                <a:ea typeface="Osaka" charset="-128"/>
                <a:cs typeface="Times New Roman" panose="02020603050405020304" pitchFamily="18" charset="0"/>
              </a:rPr>
              <a:t>Table S6. </a:t>
            </a:r>
            <a:r>
              <a:rPr lang="en-US" altLang="ja-JP" sz="1200" dirty="0">
                <a:latin typeface="Times New Roman" panose="02020603050405020304" pitchFamily="18" charset="0"/>
                <a:ea typeface="Osaka" charset="-128"/>
                <a:cs typeface="Times New Roman" panose="02020603050405020304" pitchFamily="18" charset="0"/>
              </a:rPr>
              <a:t>Pleiotropic effects with adjustment for age, sex, cohort region, and alcohol frequency</a:t>
            </a:r>
            <a:endParaRPr lang="ja-JP" altLang="en-US" sz="1200" dirty="0">
              <a:latin typeface="Times New Roman" panose="02020603050405020304" pitchFamily="18" charset="0"/>
              <a:ea typeface="Osaka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5655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7078</TotalTime>
  <Words>844</Words>
  <Application>Microsoft Office PowerPoint</Application>
  <PresentationFormat>画面に合わせる (4:3)</PresentationFormat>
  <Paragraphs>544</Paragraphs>
  <Slides>5</Slides>
  <Notes>5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3" baseType="lpstr">
      <vt:lpstr>ＭＳ Ｐゴシック</vt:lpstr>
      <vt:lpstr>Osaka</vt:lpstr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nate</dc:creator>
  <cp:lastModifiedBy>賈　慧娟</cp:lastModifiedBy>
  <cp:revision>525</cp:revision>
  <cp:lastPrinted>2017-04-07T09:24:34Z</cp:lastPrinted>
  <dcterms:created xsi:type="dcterms:W3CDTF">2015-02-05T06:20:39Z</dcterms:created>
  <dcterms:modified xsi:type="dcterms:W3CDTF">2019-06-26T03:07:23Z</dcterms:modified>
</cp:coreProperties>
</file>